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61" r:id="rId5"/>
    <p:sldId id="259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1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175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217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674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566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774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50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119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161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390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256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419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F500B2-7EA1-4F39-AFAC-33F871FB51E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EDF11-B66B-429C-9E7B-3B37BE944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642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133798"/>
            <a:ext cx="8991600" cy="23918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 descr="http://www.genebee.msu.su/trash/tr779594_1w.png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70" t="8112" r="10642" b="7384"/>
          <a:stretch/>
        </p:blipFill>
        <p:spPr bwMode="auto">
          <a:xfrm>
            <a:off x="381000" y="2678052"/>
            <a:ext cx="4853305" cy="376809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04800" y="-6514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" y="237325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400617" y="6492114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/>
              <a:t>S1 </a:t>
            </a:r>
          </a:p>
        </p:txBody>
      </p:sp>
    </p:spTree>
    <p:extLst>
      <p:ext uri="{BB962C8B-B14F-4D97-AF65-F5344CB8AC3E}">
        <p14:creationId xmlns:p14="http://schemas.microsoft.com/office/powerpoint/2010/main" val="2047431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sarumugam\Downloads\Ov and Bm 103 Localization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4821" y="0"/>
            <a:ext cx="4476798" cy="6324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400617" y="6492114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/>
              <a:t>S2 </a:t>
            </a:r>
          </a:p>
        </p:txBody>
      </p:sp>
    </p:spTree>
    <p:extLst>
      <p:ext uri="{BB962C8B-B14F-4D97-AF65-F5344CB8AC3E}">
        <p14:creationId xmlns:p14="http://schemas.microsoft.com/office/powerpoint/2010/main" val="23280675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71" y="76200"/>
            <a:ext cx="9067799" cy="22039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 descr="http://www.genebee.msu.su/trash/tr774300_2w.png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30" t="5859" r="5744" b="6483"/>
          <a:stretch/>
        </p:blipFill>
        <p:spPr bwMode="auto">
          <a:xfrm>
            <a:off x="304800" y="2667000"/>
            <a:ext cx="5325110" cy="376732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04800" y="-6514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04800" y="228600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400617" y="6492114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/>
              <a:t>S3 </a:t>
            </a:r>
          </a:p>
        </p:txBody>
      </p:sp>
    </p:spTree>
    <p:extLst>
      <p:ext uri="{BB962C8B-B14F-4D97-AF65-F5344CB8AC3E}">
        <p14:creationId xmlns:p14="http://schemas.microsoft.com/office/powerpoint/2010/main" val="39865531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67200" y="64008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/>
              <a:t>S4 </a:t>
            </a:r>
          </a:p>
        </p:txBody>
      </p:sp>
      <p:pic>
        <p:nvPicPr>
          <p:cNvPr id="2050" name="Picture 2" descr="C:\Users\sarumugam\Downloads\Ov and Bm RAL2 Localization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8838" y="15114"/>
            <a:ext cx="4434637" cy="63276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444276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66800" y="838201"/>
            <a:ext cx="6798044" cy="299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000" i="1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Ov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103-RAL2    1 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DLLSEAGDFF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HFTD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SLFAKDEKQLQQS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VK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LA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D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M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SM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P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A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M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K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T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/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i="1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Bm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103-RAL2    1 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DLLSEAGDFF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HFTD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F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SLFAKDEKQLQQS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VK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LA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D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A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K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A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K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G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T</a:t>
            </a:r>
          </a:p>
          <a:p>
            <a:pPr>
              <a:lnSpc>
                <a:spcPct val="115000"/>
              </a:lnSpc>
            </a:pP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/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i="1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Ov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103-RAL2   61 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G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G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IS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F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RE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M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SNP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M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F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EN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WE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KIF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GLN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I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PLLQK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NSA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G</a:t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i="1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Bm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103-RAL2   61 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G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Y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IS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F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K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FD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M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F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EN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WE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KIF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GLN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L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PLLQK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NSA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S</a:t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                                             </a:t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i="1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Ov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103-RAL2  121 TG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G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GGSGGGGSPQR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QQQ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Q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RDE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IPPF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GAP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P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D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F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Y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LK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DE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TD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</a:t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i="1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Bm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103-RAL2  121 A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G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PDVPETNQQCP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TGMT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RE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LPQP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IPPF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GAP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SH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K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F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F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LK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DE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TD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P</a:t>
            </a:r>
          </a:p>
          <a:p>
            <a:pPr>
              <a:lnSpc>
                <a:spcPct val="115000"/>
              </a:lnSpc>
            </a:pP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/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i="1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Ov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103-RAL2  181 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TEA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AFI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RLGG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Y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K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RF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F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M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K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Y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IHQ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V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FSPA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K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D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MSAI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/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Bm-103-RAL2  181 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TEA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AFI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RLGG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D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Y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RF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F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K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KK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Y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IHQ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FSPA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R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D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MSAI</a:t>
            </a:r>
          </a:p>
          <a:p>
            <a:pPr>
              <a:lnSpc>
                <a:spcPct val="115000"/>
              </a:lnSpc>
            </a:pP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/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i="1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Ov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103-RAL2  241 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DS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PH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T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T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S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I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IMDSLSE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V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I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I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LSP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E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/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r>
              <a:rPr lang="en-US" sz="1000" i="1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Bm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103-RAL2  241 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DS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TQ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LT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N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H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T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I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AIMDSLSE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A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VR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K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EI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L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E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808080"/>
                </a:highlight>
                <a:latin typeface="Courier New"/>
                <a:ea typeface="SimSun"/>
                <a:cs typeface="Times New Roman"/>
              </a:rPr>
              <a:t>G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FNS</a:t>
            </a:r>
            <a:r>
              <a:rPr lang="en-US" sz="10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SimSun"/>
                <a:cs typeface="Times New Roman"/>
              </a:rPr>
              <a:t>Q</a:t>
            </a:r>
            <a: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  <a:t>-</a:t>
            </a:r>
            <a:br>
              <a:rPr lang="en-US" sz="10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SimSun"/>
                <a:cs typeface="Times New Roman"/>
              </a:rPr>
            </a:br>
            <a:endParaRPr lang="en-US" sz="2400" dirty="0">
              <a:ea typeface="SimSun"/>
              <a:cs typeface="Times New Roman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286000" y="841408"/>
            <a:ext cx="4800600" cy="381000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2514601" y="1905000"/>
            <a:ext cx="1600200" cy="381000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2229050" y="1374808"/>
            <a:ext cx="4857549" cy="381000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2133600" y="2463581"/>
            <a:ext cx="4953000" cy="381000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4191000" y="1905000"/>
            <a:ext cx="2895600" cy="381000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2098307" y="2971800"/>
            <a:ext cx="3311893" cy="381000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7217143" y="1144719"/>
            <a:ext cx="6477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103</a:t>
            </a:r>
            <a:endParaRPr lang="en-US" sz="1200" b="1" dirty="0"/>
          </a:p>
        </p:txBody>
      </p:sp>
      <p:sp>
        <p:nvSpPr>
          <p:cNvPr id="18" name="Right Brace 17"/>
          <p:cNvSpPr/>
          <p:nvPr/>
        </p:nvSpPr>
        <p:spPr>
          <a:xfrm>
            <a:off x="7086600" y="1031908"/>
            <a:ext cx="152400" cy="533400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ight Brace 18"/>
          <p:cNvSpPr/>
          <p:nvPr/>
        </p:nvSpPr>
        <p:spPr>
          <a:xfrm>
            <a:off x="7086599" y="2019300"/>
            <a:ext cx="152400" cy="1143000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7162799" y="2463581"/>
            <a:ext cx="6477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AL2</a:t>
            </a:r>
            <a:endParaRPr lang="en-US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990849" y="2200004"/>
            <a:ext cx="6477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linker</a:t>
            </a:r>
            <a:endParaRPr lang="en-US" sz="1200" b="1" dirty="0"/>
          </a:p>
        </p:txBody>
      </p:sp>
      <p:sp>
        <p:nvSpPr>
          <p:cNvPr id="22" name="Rectangle 21"/>
          <p:cNvSpPr/>
          <p:nvPr/>
        </p:nvSpPr>
        <p:spPr>
          <a:xfrm>
            <a:off x="5448999" y="2933385"/>
            <a:ext cx="117371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/>
              <a:t>Sequence Identity </a:t>
            </a:r>
          </a:p>
          <a:p>
            <a:r>
              <a:rPr lang="en-US" sz="1000" b="1" dirty="0" smtClean="0"/>
              <a:t>     60%</a:t>
            </a:r>
            <a:endParaRPr lang="en-US" sz="1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267200" y="64008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/>
              <a:t>S5 </a:t>
            </a:r>
          </a:p>
        </p:txBody>
      </p:sp>
    </p:spTree>
    <p:extLst>
      <p:ext uri="{BB962C8B-B14F-4D97-AF65-F5344CB8AC3E}">
        <p14:creationId xmlns:p14="http://schemas.microsoft.com/office/powerpoint/2010/main" val="41967032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2</TotalTime>
  <Words>25</Words>
  <Application>Microsoft Office PowerPoint</Application>
  <PresentationFormat>On-screen Show (4:3)</PresentationFormat>
  <Paragraphs>18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dhar Arumugam</dc:creator>
  <cp:lastModifiedBy>Sridhar Arumugam</cp:lastModifiedBy>
  <cp:revision>14</cp:revision>
  <dcterms:created xsi:type="dcterms:W3CDTF">2016-01-30T18:38:22Z</dcterms:created>
  <dcterms:modified xsi:type="dcterms:W3CDTF">2016-03-15T20:58:57Z</dcterms:modified>
</cp:coreProperties>
</file>